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BA564B-E178-41A9-BB86-D809E5B3C8B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487EB-19F7-4F44-B383-389D5C10EC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00EA7E-7785-4E1F-9871-B92649C106D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CA69FF-3A0B-445D-BCF7-F36B3757C4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BEB5A1-4215-451E-96BB-32685457F9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75861F-E696-4559-948E-BCCFA4FD2A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F66F95-D32C-40A8-985A-1404D67546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56D6D-A760-4B3C-9B68-96129D2857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7F5DB8-D563-44B4-940A-059AB586EF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8E1AFD-FF4E-4C04-A2DE-FBFC867443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B3EBEC-8D59-46C4-A645-51CE5CCEAE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4481EE-AE48-4761-BA52-FE078973C8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0982A5-B553-4E3D-9AF3-32352F327C9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57040" y="552600"/>
            <a:ext cx="4082760" cy="3833640"/>
            <a:chOff x="257040" y="552600"/>
            <a:chExt cx="4082760" cy="3833640"/>
          </a:xfrm>
        </p:grpSpPr>
        <p:sp>
          <p:nvSpPr>
            <p:cNvPr id="42" name=""/>
            <p:cNvSpPr/>
            <p:nvPr/>
          </p:nvSpPr>
          <p:spPr>
            <a:xfrm rot="16200000">
              <a:off x="-171000" y="1314360"/>
              <a:ext cx="113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Untransfect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Grafik 28" descr="Fluo_yfp_serum.png"/>
            <p:cNvPicPr/>
            <p:nvPr/>
          </p:nvPicPr>
          <p:blipFill>
            <a:blip r:embed="rId1"/>
            <a:srcRect l="3877" t="2346" r="0" b="38835"/>
            <a:stretch/>
          </p:blipFill>
          <p:spPr>
            <a:xfrm>
              <a:off x="560160" y="789120"/>
              <a:ext cx="3779640" cy="3597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"/>
            <p:cNvSpPr/>
            <p:nvPr/>
          </p:nvSpPr>
          <p:spPr>
            <a:xfrm>
              <a:off x="944280" y="552600"/>
              <a:ext cx="741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Hoechs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219040" y="552600"/>
              <a:ext cx="43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p2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294000" y="552600"/>
              <a:ext cx="61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Mer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rot="16200000">
              <a:off x="-43920" y="2482200"/>
              <a:ext cx="878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p27wt ex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 rot="16200000">
              <a:off x="-39240" y="3666960"/>
              <a:ext cx="869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p27wt s.s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" name=""/>
          <p:cNvGrpSpPr/>
          <p:nvPr/>
        </p:nvGrpSpPr>
        <p:grpSpPr>
          <a:xfrm>
            <a:off x="4675320" y="552600"/>
            <a:ext cx="4055400" cy="5054400"/>
            <a:chOff x="4675320" y="552600"/>
            <a:chExt cx="4055400" cy="5054400"/>
          </a:xfrm>
        </p:grpSpPr>
        <p:sp>
          <p:nvSpPr>
            <p:cNvPr id="50" name=""/>
            <p:cNvSpPr/>
            <p:nvPr/>
          </p:nvSpPr>
          <p:spPr>
            <a:xfrm>
              <a:off x="5325480" y="552600"/>
              <a:ext cx="741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Hoechs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6663960" y="552600"/>
              <a:ext cx="43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p2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7713720" y="552600"/>
              <a:ext cx="61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Mer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3" name="Grafik 30" descr="Fluo_gfp_serum_and_starved.png"/>
            <p:cNvPicPr/>
            <p:nvPr/>
          </p:nvPicPr>
          <p:blipFill>
            <a:blip r:embed="rId2"/>
            <a:srcRect l="4095" t="22746" r="0" b="0"/>
            <a:stretch/>
          </p:blipFill>
          <p:spPr>
            <a:xfrm>
              <a:off x="4952520" y="889200"/>
              <a:ext cx="3778200" cy="4717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"/>
            <p:cNvSpPr/>
            <p:nvPr/>
          </p:nvSpPr>
          <p:spPr>
            <a:xfrm>
              <a:off x="5041440" y="793800"/>
              <a:ext cx="367020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rot="16200000">
              <a:off x="4262760" y="1312200"/>
              <a:ext cx="1101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p27fs177 ex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rot="16200000">
              <a:off x="4267440" y="2457000"/>
              <a:ext cx="1092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p27fs177 s.s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rot="16200000">
              <a:off x="4211640" y="3672720"/>
              <a:ext cx="1203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p27G177X ex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rot="16200000">
              <a:off x="4216320" y="4830120"/>
              <a:ext cx="1194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p27G177X s.s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"/>
          <p:cNvSpPr/>
          <p:nvPr/>
        </p:nvSpPr>
        <p:spPr>
          <a:xfrm>
            <a:off x="237960" y="85680"/>
            <a:ext cx="145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dditional Fil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8T10:34:22Z</dcterms:created>
  <dc:creator>natalia.pellegata</dc:creator>
  <dc:description/>
  <dc:language>en-US</dc:language>
  <cp:lastModifiedBy>natalia.pellegata</cp:lastModifiedBy>
  <dcterms:modified xsi:type="dcterms:W3CDTF">2010-05-18T10:34:34Z</dcterms:modified>
  <cp:revision>1</cp:revision>
  <dc:subject/>
  <dc:title>Slide 1</dc:title>
</cp:coreProperties>
</file>